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wmf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wmf"/><Relationship Id="rId1" Type="http://schemas.openxmlformats.org/officeDocument/2006/relationships/image" Target="../media/image30.emf"/><Relationship Id="rId6" Type="http://schemas.openxmlformats.org/officeDocument/2006/relationships/image" Target="../media/image35.emf"/><Relationship Id="rId5" Type="http://schemas.openxmlformats.org/officeDocument/2006/relationships/image" Target="../media/image34.emf"/><Relationship Id="rId4" Type="http://schemas.openxmlformats.org/officeDocument/2006/relationships/image" Target="../media/image33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image" Target="../media/image40.emf"/><Relationship Id="rId1" Type="http://schemas.openxmlformats.org/officeDocument/2006/relationships/image" Target="../media/image39.emf"/><Relationship Id="rId6" Type="http://schemas.openxmlformats.org/officeDocument/2006/relationships/image" Target="../media/image44.emf"/><Relationship Id="rId5" Type="http://schemas.openxmlformats.org/officeDocument/2006/relationships/image" Target="../media/image43.emf"/><Relationship Id="rId4" Type="http://schemas.openxmlformats.org/officeDocument/2006/relationships/image" Target="../media/image4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3235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9274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29516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8512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0946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50561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30079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098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66161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18102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97241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E835F-C789-48B4-9B29-508980288DE6}" type="datetimeFigureOut">
              <a:rPr lang="en-IN" smtClean="0"/>
              <a:t>09-03-20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42062-C9C0-49A3-8DF2-24DA847BE2C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63051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8.bin"/><Relationship Id="rId18" Type="http://schemas.openxmlformats.org/officeDocument/2006/relationships/image" Target="../media/image12.png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7.emf"/><Relationship Id="rId17" Type="http://schemas.openxmlformats.org/officeDocument/2006/relationships/image" Target="../media/image11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0.png"/><Relationship Id="rId20" Type="http://schemas.openxmlformats.org/officeDocument/2006/relationships/image" Target="../media/image14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5" Type="http://schemas.openxmlformats.org/officeDocument/2006/relationships/image" Target="../media/image9.png"/><Relationship Id="rId10" Type="http://schemas.openxmlformats.org/officeDocument/2006/relationships/image" Target="../media/image6.emf"/><Relationship Id="rId19" Type="http://schemas.openxmlformats.org/officeDocument/2006/relationships/image" Target="../media/image13.png"/><Relationship Id="rId4" Type="http://schemas.openxmlformats.org/officeDocument/2006/relationships/image" Target="../media/image3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oleObject" Target="../embeddings/oleObject14.bin"/><Relationship Id="rId18" Type="http://schemas.openxmlformats.org/officeDocument/2006/relationships/image" Target="../media/image24.png"/><Relationship Id="rId3" Type="http://schemas.openxmlformats.org/officeDocument/2006/relationships/oleObject" Target="../embeddings/oleObject9.bin"/><Relationship Id="rId21" Type="http://schemas.openxmlformats.org/officeDocument/2006/relationships/image" Target="../media/image27.png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19.emf"/><Relationship Id="rId17" Type="http://schemas.openxmlformats.org/officeDocument/2006/relationships/image" Target="../media/image23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2.png"/><Relationship Id="rId20" Type="http://schemas.openxmlformats.org/officeDocument/2006/relationships/image" Target="../media/image26.png"/><Relationship Id="rId1" Type="http://schemas.openxmlformats.org/officeDocument/2006/relationships/vmlDrawing" Target="../drawings/vmlDrawing3.vml"/><Relationship Id="rId6" Type="http://schemas.openxmlformats.org/officeDocument/2006/relationships/image" Target="../media/image16.emf"/><Relationship Id="rId11" Type="http://schemas.openxmlformats.org/officeDocument/2006/relationships/oleObject" Target="../embeddings/oleObject13.bin"/><Relationship Id="rId5" Type="http://schemas.openxmlformats.org/officeDocument/2006/relationships/oleObject" Target="../embeddings/oleObject10.bin"/><Relationship Id="rId15" Type="http://schemas.openxmlformats.org/officeDocument/2006/relationships/image" Target="../media/image21.png"/><Relationship Id="rId23" Type="http://schemas.openxmlformats.org/officeDocument/2006/relationships/image" Target="../media/image29.png"/><Relationship Id="rId10" Type="http://schemas.openxmlformats.org/officeDocument/2006/relationships/image" Target="../media/image18.emf"/><Relationship Id="rId19" Type="http://schemas.openxmlformats.org/officeDocument/2006/relationships/image" Target="../media/image25.png"/><Relationship Id="rId4" Type="http://schemas.openxmlformats.org/officeDocument/2006/relationships/image" Target="../media/image15.wmf"/><Relationship Id="rId9" Type="http://schemas.openxmlformats.org/officeDocument/2006/relationships/oleObject" Target="../embeddings/oleObject12.bin"/><Relationship Id="rId14" Type="http://schemas.openxmlformats.org/officeDocument/2006/relationships/image" Target="../media/image20.emf"/><Relationship Id="rId22" Type="http://schemas.openxmlformats.org/officeDocument/2006/relationships/image" Target="../media/image2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emf"/><Relationship Id="rId13" Type="http://schemas.openxmlformats.org/officeDocument/2006/relationships/oleObject" Target="../embeddings/oleObject20.bin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12" Type="http://schemas.openxmlformats.org/officeDocument/2006/relationships/image" Target="../media/image34.emf"/><Relationship Id="rId17" Type="http://schemas.openxmlformats.org/officeDocument/2006/relationships/image" Target="../media/image38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7.png"/><Relationship Id="rId1" Type="http://schemas.openxmlformats.org/officeDocument/2006/relationships/vmlDrawing" Target="../drawings/vmlDrawing4.vml"/><Relationship Id="rId6" Type="http://schemas.openxmlformats.org/officeDocument/2006/relationships/image" Target="../media/image31.wmf"/><Relationship Id="rId11" Type="http://schemas.openxmlformats.org/officeDocument/2006/relationships/oleObject" Target="../embeddings/oleObject19.bin"/><Relationship Id="rId5" Type="http://schemas.openxmlformats.org/officeDocument/2006/relationships/oleObject" Target="../embeddings/oleObject16.bin"/><Relationship Id="rId15" Type="http://schemas.openxmlformats.org/officeDocument/2006/relationships/image" Target="../media/image36.png"/><Relationship Id="rId10" Type="http://schemas.openxmlformats.org/officeDocument/2006/relationships/image" Target="../media/image33.emf"/><Relationship Id="rId4" Type="http://schemas.openxmlformats.org/officeDocument/2006/relationships/image" Target="../media/image30.emf"/><Relationship Id="rId9" Type="http://schemas.openxmlformats.org/officeDocument/2006/relationships/oleObject" Target="../embeddings/oleObject18.bin"/><Relationship Id="rId14" Type="http://schemas.openxmlformats.org/officeDocument/2006/relationships/image" Target="../media/image35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13" Type="http://schemas.openxmlformats.org/officeDocument/2006/relationships/oleObject" Target="../embeddings/oleObject26.bin"/><Relationship Id="rId18" Type="http://schemas.openxmlformats.org/officeDocument/2006/relationships/image" Target="../media/image48.png"/><Relationship Id="rId3" Type="http://schemas.openxmlformats.org/officeDocument/2006/relationships/oleObject" Target="../embeddings/oleObject21.bin"/><Relationship Id="rId7" Type="http://schemas.openxmlformats.org/officeDocument/2006/relationships/oleObject" Target="../embeddings/oleObject23.bin"/><Relationship Id="rId12" Type="http://schemas.openxmlformats.org/officeDocument/2006/relationships/image" Target="../media/image43.emf"/><Relationship Id="rId17" Type="http://schemas.openxmlformats.org/officeDocument/2006/relationships/image" Target="../media/image47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6.png"/><Relationship Id="rId20" Type="http://schemas.openxmlformats.org/officeDocument/2006/relationships/image" Target="../media/image50.png"/><Relationship Id="rId1" Type="http://schemas.openxmlformats.org/officeDocument/2006/relationships/vmlDrawing" Target="../drawings/vmlDrawing5.vml"/><Relationship Id="rId6" Type="http://schemas.openxmlformats.org/officeDocument/2006/relationships/image" Target="../media/image40.emf"/><Relationship Id="rId11" Type="http://schemas.openxmlformats.org/officeDocument/2006/relationships/oleObject" Target="../embeddings/oleObject25.bin"/><Relationship Id="rId5" Type="http://schemas.openxmlformats.org/officeDocument/2006/relationships/oleObject" Target="../embeddings/oleObject22.bin"/><Relationship Id="rId15" Type="http://schemas.openxmlformats.org/officeDocument/2006/relationships/image" Target="../media/image45.png"/><Relationship Id="rId10" Type="http://schemas.openxmlformats.org/officeDocument/2006/relationships/image" Target="../media/image42.emf"/><Relationship Id="rId19" Type="http://schemas.openxmlformats.org/officeDocument/2006/relationships/image" Target="../media/image49.png"/><Relationship Id="rId4" Type="http://schemas.openxmlformats.org/officeDocument/2006/relationships/image" Target="../media/image39.emf"/><Relationship Id="rId9" Type="http://schemas.openxmlformats.org/officeDocument/2006/relationships/oleObject" Target="../embeddings/oleObject24.bin"/><Relationship Id="rId14" Type="http://schemas.openxmlformats.org/officeDocument/2006/relationships/image" Target="../media/image4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58046" y="2071891"/>
            <a:ext cx="4177145" cy="1099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The basal expression level of </a:t>
            </a:r>
            <a:r>
              <a:rPr lang="en-US" sz="818" b="1" i="1" dirty="0">
                <a:latin typeface="Arial" panose="020B0604020202020204" pitchFamily="34" charset="0"/>
                <a:cs typeface="Arial" panose="020B0604020202020204" pitchFamily="34" charset="0"/>
              </a:rPr>
              <a:t>FXN</a:t>
            </a:r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 mRNA in homozygous (+/+) or hemizygous (+/-) FA model mice.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 (A) neonatal and (B) adult mice. Expression in all brain parts and genotype compared to brain cortex +/+. Two-way ANOVA (Tukey’s post-hoc) # - p&lt;0.05, * - p&lt;0.01 (vs. other brain parts with matching genotype); Genotype x Brain part interaction p&lt;0.05. Note. FXN raw Ct values: neonatal +/-: ~26.5, ~26.3, ~25.7; +/+: ~25.4, ~25.2, ~24.6; adult +/-: ~25.8, ~25.6, ~25.2; +/+: ~25.0, ~24.7, ~24.3; brain cortex, cerebellum and spinal cord respectively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81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687387" y="118456"/>
            <a:ext cx="3897976" cy="2034443"/>
            <a:chOff x="353568" y="173736"/>
            <a:chExt cx="5717032" cy="2983850"/>
          </a:xfrm>
        </p:grpSpPr>
        <p:graphicFrame>
          <p:nvGraphicFramePr>
            <p:cNvPr id="3" name="Object 2"/>
            <p:cNvGraphicFramePr>
              <a:graphicFrameLocks noChangeAspect="1"/>
            </p:cNvGraphicFramePr>
            <p:nvPr>
              <p:extLst/>
            </p:nvPr>
          </p:nvGraphicFramePr>
          <p:xfrm>
            <a:off x="377825" y="219075"/>
            <a:ext cx="2886075" cy="2384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name="Prism 9" r:id="rId3" imgW="2886128" imgH="2384580" progId="Prism9.Document">
                    <p:embed/>
                  </p:oleObj>
                </mc:Choice>
                <mc:Fallback>
                  <p:oleObj name="Prism 9" r:id="rId3" imgW="2886128" imgH="2384580" progId="Prism9.Document">
                    <p:embed/>
                    <p:pic>
                      <p:nvPicPr>
                        <p:cNvPr id="3" name="Object 2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77825" y="219075"/>
                          <a:ext cx="2886075" cy="23844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7" name="Straight Connector 16"/>
            <p:cNvCxnSpPr/>
            <p:nvPr/>
          </p:nvCxnSpPr>
          <p:spPr>
            <a:xfrm>
              <a:off x="1031685" y="2560320"/>
              <a:ext cx="5834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1663056" y="2560320"/>
              <a:ext cx="5834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2277011" y="2560320"/>
              <a:ext cx="5834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1066521" y="2560320"/>
              <a:ext cx="566057" cy="5972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82" dirty="0"/>
                <a:t>Brain Cortex</a:t>
              </a:r>
              <a:endParaRPr lang="lt-LT" sz="682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532429" y="2651760"/>
              <a:ext cx="822960" cy="443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82" dirty="0"/>
                <a:t>Cerebellum</a:t>
              </a:r>
              <a:endParaRPr lang="lt-LT" sz="682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298783" y="2560320"/>
              <a:ext cx="566057" cy="5972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82" dirty="0"/>
                <a:t>Spinal Cord</a:t>
              </a:r>
              <a:endParaRPr lang="lt-LT" sz="682" dirty="0"/>
            </a:p>
          </p:txBody>
        </p:sp>
        <p:graphicFrame>
          <p:nvGraphicFramePr>
            <p:cNvPr id="19" name="Object 18"/>
            <p:cNvGraphicFramePr>
              <a:graphicFrameLocks/>
            </p:cNvGraphicFramePr>
            <p:nvPr>
              <p:extLst/>
            </p:nvPr>
          </p:nvGraphicFramePr>
          <p:xfrm>
            <a:off x="3184525" y="219075"/>
            <a:ext cx="2886075" cy="2387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9" r:id="rId5" imgW="2886128" imgH="2494427" progId="Prism9.Document">
                    <p:embed/>
                  </p:oleObj>
                </mc:Choice>
                <mc:Fallback>
                  <p:oleObj name="Prism 9" r:id="rId5" imgW="2886128" imgH="2494427" progId="Prism9.Document">
                    <p:embed/>
                    <p:pic>
                      <p:nvPicPr>
                        <p:cNvPr id="19" name="Object 18"/>
                        <p:cNvPicPr preferRelativeResize="0"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184525" y="219075"/>
                          <a:ext cx="2886075" cy="23876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20" name="Straight Connector 19"/>
            <p:cNvCxnSpPr/>
            <p:nvPr/>
          </p:nvCxnSpPr>
          <p:spPr>
            <a:xfrm>
              <a:off x="3885235" y="2563043"/>
              <a:ext cx="5834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4516606" y="2558689"/>
              <a:ext cx="5834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5130561" y="2563043"/>
              <a:ext cx="5834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3920070" y="2560320"/>
              <a:ext cx="566057" cy="5972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82" dirty="0"/>
                <a:t>Brain Cortex</a:t>
              </a:r>
              <a:endParaRPr lang="lt-LT" sz="682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385979" y="2560320"/>
              <a:ext cx="822960" cy="4433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82" dirty="0"/>
                <a:t>Cerebellum</a:t>
              </a:r>
              <a:endParaRPr lang="lt-LT" sz="682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152333" y="2560320"/>
              <a:ext cx="566057" cy="5972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82" dirty="0"/>
                <a:t>Spinal Cord</a:t>
              </a:r>
              <a:endParaRPr lang="lt-LT" sz="682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108960" y="173736"/>
              <a:ext cx="475488" cy="35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55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lt-LT" sz="95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53568" y="173736"/>
              <a:ext cx="475488" cy="3509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55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lt-LT" sz="955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997993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/>
          </p:cNvGraphicFramePr>
          <p:nvPr>
            <p:extLst/>
          </p:nvPr>
        </p:nvGraphicFramePr>
        <p:xfrm>
          <a:off x="6519949" y="149629"/>
          <a:ext cx="1427711" cy="1458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Prism 9" r:id="rId3" imgW="2484936" imgH="2576542" progId="Prism9.Document">
                  <p:embed/>
                </p:oleObj>
              </mc:Choice>
              <mc:Fallback>
                <p:oleObj name="Prism 9" r:id="rId3" imgW="2484936" imgH="2576542" progId="Prism9.Document">
                  <p:embed/>
                  <p:pic>
                    <p:nvPicPr>
                      <p:cNvPr id="4" name="Object 3"/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519949" y="149629"/>
                        <a:ext cx="1427711" cy="1458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3633355" y="149629"/>
          <a:ext cx="1427711" cy="1458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Prism 9" r:id="rId5" imgW="2484936" imgH="2576542" progId="Prism9.Document">
                  <p:embed/>
                </p:oleObj>
              </mc:Choice>
              <mc:Fallback>
                <p:oleObj name="Prism 9" r:id="rId5" imgW="2484936" imgH="2576542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33355" y="149629"/>
                        <a:ext cx="1427711" cy="1458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/>
          </p:cNvGraphicFramePr>
          <p:nvPr>
            <p:extLst/>
          </p:nvPr>
        </p:nvGraphicFramePr>
        <p:xfrm>
          <a:off x="5079769" y="149629"/>
          <a:ext cx="1427711" cy="1458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" name="Prism 9" r:id="rId7" imgW="2484936" imgH="2576542" progId="Prism9.Document">
                  <p:embed/>
                </p:oleObj>
              </mc:Choice>
              <mc:Fallback>
                <p:oleObj name="Prism 9" r:id="rId7" imgW="2484936" imgH="2576542" progId="Prism9.Document">
                  <p:embed/>
                  <p:pic>
                    <p:nvPicPr>
                      <p:cNvPr id="6" name="Object 5"/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079769" y="149629"/>
                        <a:ext cx="1427711" cy="1458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8" name="TextBox 37"/>
          <p:cNvSpPr txBox="1"/>
          <p:nvPr/>
        </p:nvSpPr>
        <p:spPr>
          <a:xfrm>
            <a:off x="3577244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016632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447362" y="121898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>
            <a:spLocks noChangeAspect="1"/>
          </p:cNvSpPr>
          <p:nvPr/>
        </p:nvSpPr>
        <p:spPr>
          <a:xfrm>
            <a:off x="3758046" y="4372892"/>
            <a:ext cx="4177145" cy="721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Effect on </a:t>
            </a:r>
            <a:r>
              <a:rPr lang="en-US" sz="818" b="1" i="1" dirty="0">
                <a:latin typeface="Arial" panose="020B0604020202020204" pitchFamily="34" charset="0"/>
                <a:cs typeface="Arial" panose="020B0604020202020204" pitchFamily="34" charset="0"/>
              </a:rPr>
              <a:t>FXN</a:t>
            </a:r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 mRNA and protein levels from ICV administration of steric blocking (500 </a:t>
            </a:r>
            <a:r>
              <a:rPr lang="el-GR" sz="818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g) ASO M-4 in adult mice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qPCR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data analyzed with additional reference genes </a:t>
            </a:r>
            <a:r>
              <a:rPr lang="en-US" sz="818" i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818" i="1" dirty="0">
                <a:latin typeface="Arial" panose="020B0604020202020204" pitchFamily="34" charset="0"/>
                <a:cs typeface="Arial" panose="020B0604020202020204" pitchFamily="34" charset="0"/>
              </a:rPr>
              <a:t>Hprt1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blot data, related to Fig. 2. (A) Brain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cortex.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Cerebellum.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(C) Spinal cord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AVG±SEM. T-test # - p&lt;0.05, * - p&lt;0.01.</a:t>
            </a:r>
            <a:endParaRPr lang="lt-LT" sz="81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/>
          </p:cNvGraphicFramePr>
          <p:nvPr>
            <p:extLst/>
          </p:nvPr>
        </p:nvGraphicFramePr>
        <p:xfrm>
          <a:off x="3633355" y="1683327"/>
          <a:ext cx="1427711" cy="1458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9" name="Prism 9" r:id="rId9" imgW="2484936" imgH="2576542" progId="Prism9.Document">
                  <p:embed/>
                </p:oleObj>
              </mc:Choice>
              <mc:Fallback>
                <p:oleObj name="Prism 9" r:id="rId9" imgW="2484936" imgH="2576542" progId="Prism9.Document">
                  <p:embed/>
                  <p:pic>
                    <p:nvPicPr>
                      <p:cNvPr id="3" name="Object 2"/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33355" y="1683327"/>
                        <a:ext cx="1427711" cy="1458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/>
          </p:cNvGraphicFramePr>
          <p:nvPr>
            <p:extLst/>
          </p:nvPr>
        </p:nvGraphicFramePr>
        <p:xfrm>
          <a:off x="5079769" y="1683327"/>
          <a:ext cx="1427711" cy="1458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Prism 9" r:id="rId11" imgW="2484936" imgH="2576542" progId="Prism9.Document">
                  <p:embed/>
                </p:oleObj>
              </mc:Choice>
              <mc:Fallback>
                <p:oleObj name="Prism 9" r:id="rId11" imgW="2484936" imgH="2576542" progId="Prism9.Document">
                  <p:embed/>
                  <p:pic>
                    <p:nvPicPr>
                      <p:cNvPr id="7" name="Object 6"/>
                      <p:cNvPicPr preferRelativeResize="0"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079769" y="1683327"/>
                        <a:ext cx="1427711" cy="1458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/>
          </p:cNvGraphicFramePr>
          <p:nvPr>
            <p:extLst/>
          </p:nvPr>
        </p:nvGraphicFramePr>
        <p:xfrm>
          <a:off x="6519949" y="1683327"/>
          <a:ext cx="1427711" cy="1458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1" name="Prism 9" r:id="rId13" imgW="2484936" imgH="2576542" progId="Prism9.Document">
                  <p:embed/>
                </p:oleObj>
              </mc:Choice>
              <mc:Fallback>
                <p:oleObj name="Prism 9" r:id="rId13" imgW="2484936" imgH="2576542" progId="Prism9.Document">
                  <p:embed/>
                  <p:pic>
                    <p:nvPicPr>
                      <p:cNvPr id="5" name="Object 4"/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519949" y="1683327"/>
                        <a:ext cx="1427711" cy="1458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1" name="Picture 1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689466" y="3784369"/>
            <a:ext cx="1246909" cy="34861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689466" y="3223260"/>
            <a:ext cx="1246909" cy="356600"/>
          </a:xfrm>
          <a:prstGeom prst="rect">
            <a:avLst/>
          </a:prstGeom>
        </p:spPr>
      </p:pic>
      <p:pic>
        <p:nvPicPr>
          <p:cNvPr id="15" name="Picture 14"/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5135880" y="3223260"/>
            <a:ext cx="1246909" cy="355369"/>
          </a:xfrm>
          <a:prstGeom prst="rect">
            <a:avLst/>
          </a:prstGeom>
        </p:spPr>
      </p:pic>
      <p:pic>
        <p:nvPicPr>
          <p:cNvPr id="16" name="Picture 15"/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5135880" y="3784369"/>
            <a:ext cx="1246909" cy="355369"/>
          </a:xfrm>
          <a:prstGeom prst="rect">
            <a:avLst/>
          </a:prstGeom>
        </p:spPr>
      </p:pic>
      <p:pic>
        <p:nvPicPr>
          <p:cNvPr id="17" name="Picture 16"/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6576060" y="3223260"/>
            <a:ext cx="1246909" cy="355369"/>
          </a:xfrm>
          <a:prstGeom prst="rect">
            <a:avLst/>
          </a:prstGeom>
        </p:spPr>
      </p:pic>
      <p:pic>
        <p:nvPicPr>
          <p:cNvPr id="32" name="Picture 31"/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6576060" y="3784369"/>
            <a:ext cx="1246909" cy="3553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42626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58046" y="4318022"/>
            <a:ext cx="4177145" cy="721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Effect on </a:t>
            </a:r>
            <a:r>
              <a:rPr lang="en-US" sz="818" b="1" i="1" dirty="0">
                <a:latin typeface="Arial" panose="020B0604020202020204" pitchFamily="34" charset="0"/>
                <a:cs typeface="Arial" panose="020B0604020202020204" pitchFamily="34" charset="0"/>
              </a:rPr>
              <a:t>FXN</a:t>
            </a:r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 mRNA and protein levels from ICV administration of gapmer Gap-17 in adult mouse CNS at increasing </a:t>
            </a:r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dose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. qPCR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data analyzed with additional reference genes </a:t>
            </a:r>
            <a:r>
              <a:rPr lang="en-US" sz="818" i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818" i="1" dirty="0">
                <a:latin typeface="Arial" panose="020B0604020202020204" pitchFamily="34" charset="0"/>
                <a:cs typeface="Arial" panose="020B0604020202020204" pitchFamily="34" charset="0"/>
              </a:rPr>
              <a:t>Hprt1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blot data, related to Fig. 3.  (A) Brain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cortex.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Cerebellum.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(C) Spinal cord. AVG±SEM. T-test # - p&lt;0.05, * - p&lt;0.01.</a:t>
            </a:r>
            <a:endParaRPr lang="lt-LT" sz="81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2" name="Object 31"/>
          <p:cNvGraphicFramePr>
            <a:graphicFrameLocks noChangeAspect="1"/>
          </p:cNvGraphicFramePr>
          <p:nvPr>
            <p:extLst/>
          </p:nvPr>
        </p:nvGraphicFramePr>
        <p:xfrm>
          <a:off x="3714750" y="149369"/>
          <a:ext cx="1426585" cy="1262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0" name="Prism 9" r:id="rId3" imgW="3031200" imgH="2679120" progId="Prism9.Document">
                  <p:embed/>
                </p:oleObj>
              </mc:Choice>
              <mc:Fallback>
                <p:oleObj name="Prism 9" r:id="rId3" imgW="3031200" imgH="2679120" progId="Prism9.Document">
                  <p:embed/>
                  <p:pic>
                    <p:nvPicPr>
                      <p:cNvPr id="32" name="Object 3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14750" y="149369"/>
                        <a:ext cx="1426585" cy="1262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/>
          <p:cNvGraphicFramePr>
            <a:graphicFrameLocks noChangeAspect="1"/>
          </p:cNvGraphicFramePr>
          <p:nvPr>
            <p:extLst/>
          </p:nvPr>
        </p:nvGraphicFramePr>
        <p:xfrm>
          <a:off x="3714750" y="1423339"/>
          <a:ext cx="1427668" cy="1262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1" name="Prism 9" r:id="rId5" imgW="3032343" imgH="2680266" progId="Prism9.Document">
                  <p:embed/>
                </p:oleObj>
              </mc:Choice>
              <mc:Fallback>
                <p:oleObj name="Prism 9" r:id="rId5" imgW="3032343" imgH="2680266" progId="Prism9.Document">
                  <p:embed/>
                  <p:pic>
                    <p:nvPicPr>
                      <p:cNvPr id="33" name="Object 3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14750" y="1423339"/>
                        <a:ext cx="1427668" cy="1262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/>
          <p:cNvGraphicFramePr>
            <a:graphicFrameLocks/>
          </p:cNvGraphicFramePr>
          <p:nvPr>
            <p:extLst/>
          </p:nvPr>
        </p:nvGraphicFramePr>
        <p:xfrm>
          <a:off x="5079769" y="149629"/>
          <a:ext cx="1427711" cy="12617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2" name="Prism 9" r:id="rId7" imgW="3032343" imgH="2680266" progId="Prism9.Document">
                  <p:embed/>
                </p:oleObj>
              </mc:Choice>
              <mc:Fallback>
                <p:oleObj name="Prism 9" r:id="rId7" imgW="3032343" imgH="2680266" progId="Prism9.Document">
                  <p:embed/>
                  <p:pic>
                    <p:nvPicPr>
                      <p:cNvPr id="34" name="Object 33"/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079769" y="149629"/>
                        <a:ext cx="1427711" cy="12617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/>
          <p:cNvGraphicFramePr>
            <a:graphicFrameLocks noChangeAspect="1"/>
          </p:cNvGraphicFramePr>
          <p:nvPr>
            <p:extLst/>
          </p:nvPr>
        </p:nvGraphicFramePr>
        <p:xfrm>
          <a:off x="5079769" y="1423105"/>
          <a:ext cx="1427711" cy="12617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3" name="Prism 9" r:id="rId9" imgW="3032343" imgH="2680266" progId="Prism9.Document">
                  <p:embed/>
                </p:oleObj>
              </mc:Choice>
              <mc:Fallback>
                <p:oleObj name="Prism 9" r:id="rId9" imgW="3032343" imgH="2680266" progId="Prism9.Document">
                  <p:embed/>
                  <p:pic>
                    <p:nvPicPr>
                      <p:cNvPr id="35" name="Object 3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079769" y="1423105"/>
                        <a:ext cx="1427711" cy="12617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/>
          <p:cNvGraphicFramePr>
            <a:graphicFrameLocks noChangeAspect="1"/>
          </p:cNvGraphicFramePr>
          <p:nvPr>
            <p:extLst/>
          </p:nvPr>
        </p:nvGraphicFramePr>
        <p:xfrm>
          <a:off x="6520295" y="149369"/>
          <a:ext cx="1428750" cy="1262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4" name="Prism 9" r:id="rId11" imgW="3032343" imgH="2680266" progId="Prism9.Document">
                  <p:embed/>
                </p:oleObj>
              </mc:Choice>
              <mc:Fallback>
                <p:oleObj name="Prism 9" r:id="rId11" imgW="3032343" imgH="2680266" progId="Prism9.Document">
                  <p:embed/>
                  <p:pic>
                    <p:nvPicPr>
                      <p:cNvPr id="36" name="Object 35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520295" y="149369"/>
                        <a:ext cx="1428750" cy="1262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/>
          <p:cNvGraphicFramePr>
            <a:graphicFrameLocks noChangeAspect="1"/>
          </p:cNvGraphicFramePr>
          <p:nvPr>
            <p:extLst/>
          </p:nvPr>
        </p:nvGraphicFramePr>
        <p:xfrm>
          <a:off x="6519949" y="1423105"/>
          <a:ext cx="1427711" cy="12617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5" name="Prism 9" r:id="rId13" imgW="3032343" imgH="2680266" progId="Prism9.Document">
                  <p:embed/>
                </p:oleObj>
              </mc:Choice>
              <mc:Fallback>
                <p:oleObj name="Prism 9" r:id="rId13" imgW="3032343" imgH="2680266" progId="Prism9.Document">
                  <p:embed/>
                  <p:pic>
                    <p:nvPicPr>
                      <p:cNvPr id="37" name="Object 36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519949" y="1423105"/>
                        <a:ext cx="1427711" cy="12617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8" name="TextBox 37"/>
          <p:cNvSpPr txBox="1"/>
          <p:nvPr/>
        </p:nvSpPr>
        <p:spPr>
          <a:xfrm>
            <a:off x="3577244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004955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438900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758046" y="2730731"/>
            <a:ext cx="1246909" cy="40372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758046" y="3260667"/>
            <a:ext cx="1246909" cy="406109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758046" y="3803073"/>
            <a:ext cx="1246909" cy="404918"/>
          </a:xfrm>
          <a:prstGeom prst="rect">
            <a:avLst/>
          </a:prstGeom>
        </p:spPr>
      </p:pic>
      <p:pic>
        <p:nvPicPr>
          <p:cNvPr id="12" name="Picture 11"/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5123411" y="2730731"/>
            <a:ext cx="1246909" cy="405245"/>
          </a:xfrm>
          <a:prstGeom prst="rect">
            <a:avLst/>
          </a:prstGeom>
        </p:spPr>
      </p:pic>
      <p:pic>
        <p:nvPicPr>
          <p:cNvPr id="13" name="Picture 12"/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5123411" y="3260668"/>
            <a:ext cx="1246909" cy="405245"/>
          </a:xfrm>
          <a:prstGeom prst="rect">
            <a:avLst/>
          </a:prstGeom>
        </p:spPr>
      </p:pic>
      <p:pic>
        <p:nvPicPr>
          <p:cNvPr id="14" name="Picture 13"/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5123411" y="3803073"/>
            <a:ext cx="1246909" cy="405245"/>
          </a:xfrm>
          <a:prstGeom prst="rect">
            <a:avLst/>
          </a:prstGeom>
        </p:spPr>
      </p:pic>
      <p:pic>
        <p:nvPicPr>
          <p:cNvPr id="15" name="Picture 14"/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6563591" y="2730731"/>
            <a:ext cx="1246909" cy="405245"/>
          </a:xfrm>
          <a:prstGeom prst="rect">
            <a:avLst/>
          </a:prstGeom>
        </p:spPr>
      </p:pic>
      <p:pic>
        <p:nvPicPr>
          <p:cNvPr id="16" name="Picture 15"/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6563591" y="3260668"/>
            <a:ext cx="1246909" cy="405245"/>
          </a:xfrm>
          <a:prstGeom prst="rect">
            <a:avLst/>
          </a:prstGeom>
        </p:spPr>
      </p:pic>
      <p:pic>
        <p:nvPicPr>
          <p:cNvPr id="21" name="Picture 20"/>
          <p:cNvPicPr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6563591" y="3803073"/>
            <a:ext cx="1246909" cy="4052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036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758046" y="4627125"/>
            <a:ext cx="4177145" cy="9734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Effect on </a:t>
            </a:r>
            <a:r>
              <a:rPr lang="en-US" sz="818" b="1" i="1" dirty="0">
                <a:latin typeface="Arial" panose="020B0604020202020204" pitchFamily="34" charset="0"/>
                <a:cs typeface="Arial" panose="020B0604020202020204" pitchFamily="34" charset="0"/>
              </a:rPr>
              <a:t>FXN</a:t>
            </a:r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 mRNA and protein levels from ICV administration disabled gapmer Gap-37 in neonatal mouse at increasing </a:t>
            </a:r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dose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. qPCR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data analyzed with additional reference genes </a:t>
            </a:r>
            <a:r>
              <a:rPr lang="en-US" sz="818" i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818" i="1" dirty="0">
                <a:latin typeface="Arial" panose="020B0604020202020204" pitchFamily="34" charset="0"/>
                <a:cs typeface="Arial" panose="020B0604020202020204" pitchFamily="34" charset="0"/>
              </a:rPr>
              <a:t>Hprt1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blot data, related to Fig. 4. (A) Brain cortex. (B) Cerebellum. (C) Spinal cord. AVG±SEM. One-way ANOVA (Tukey’s post-hoc) # - p&lt;0.05, * - p&lt;0.01 (</a:t>
            </a:r>
            <a:r>
              <a:rPr lang="en-US" sz="818" i="1" dirty="0">
                <a:latin typeface="Arial" panose="020B0604020202020204" pitchFamily="34" charset="0"/>
                <a:cs typeface="Arial" panose="020B0604020202020204" pitchFamily="34" charset="0"/>
              </a:rPr>
              <a:t>vs.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 Gap-CTRL).</a:t>
            </a:r>
            <a:endParaRPr lang="lt-LT" sz="818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lt-LT" sz="81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3714750" y="1600513"/>
          <a:ext cx="1427668" cy="14861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4" name="Prism 9" r:id="rId3" imgW="2693815" imgH="2805240" progId="Prism9.Document">
                  <p:embed/>
                </p:oleObj>
              </mc:Choice>
              <mc:Fallback>
                <p:oleObj name="Prism 9" r:id="rId3" imgW="2693815" imgH="2805240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14750" y="1600513"/>
                        <a:ext cx="1427668" cy="14861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3714750" y="149369"/>
          <a:ext cx="1426585" cy="14861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5" name="Prism 9" r:id="rId5" imgW="2692800" imgH="2804040" progId="Prism9.Document">
                  <p:embed/>
                </p:oleObj>
              </mc:Choice>
              <mc:Fallback>
                <p:oleObj name="Prism 9" r:id="rId5" imgW="2692800" imgH="2804040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14750" y="149369"/>
                        <a:ext cx="1426585" cy="14861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5079640" y="149629"/>
          <a:ext cx="1427667" cy="14871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6" name="Prism 9" r:id="rId7" imgW="2693815" imgH="2805240" progId="Prism9.Document">
                  <p:embed/>
                </p:oleObj>
              </mc:Choice>
              <mc:Fallback>
                <p:oleObj name="Prism 9" r:id="rId7" imgW="2693815" imgH="2805240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079640" y="149629"/>
                        <a:ext cx="1427667" cy="14871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5079640" y="1600513"/>
          <a:ext cx="1427667" cy="14861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7" name="Prism 9" r:id="rId9" imgW="2693815" imgH="2805240" progId="Prism9.Document">
                  <p:embed/>
                </p:oleObj>
              </mc:Choice>
              <mc:Fallback>
                <p:oleObj name="Prism 9" r:id="rId9" imgW="2693815" imgH="2805240" progId="Prism9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079640" y="1600513"/>
                        <a:ext cx="1427667" cy="14861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/>
          </p:nvPr>
        </p:nvGraphicFramePr>
        <p:xfrm>
          <a:off x="6520296" y="149629"/>
          <a:ext cx="1427668" cy="14871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8" name="Prism 9" r:id="rId11" imgW="2693815" imgH="2805240" progId="Prism9.Document">
                  <p:embed/>
                </p:oleObj>
              </mc:Choice>
              <mc:Fallback>
                <p:oleObj name="Prism 9" r:id="rId11" imgW="2693815" imgH="2805240" progId="Prism9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520296" y="149629"/>
                        <a:ext cx="1427668" cy="14871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/>
          </p:nvPr>
        </p:nvGraphicFramePr>
        <p:xfrm>
          <a:off x="6520296" y="1600513"/>
          <a:ext cx="1427668" cy="14861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9" name="Prism 9" r:id="rId13" imgW="2693815" imgH="2805240" progId="Prism9.Document">
                  <p:embed/>
                </p:oleObj>
              </mc:Choice>
              <mc:Fallback>
                <p:oleObj name="Prism 9" r:id="rId13" imgW="2693815" imgH="2805240" progId="Prism9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520296" y="1600513"/>
                        <a:ext cx="1427668" cy="14861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3577244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025262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464202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776749" y="3054927"/>
            <a:ext cx="1246909" cy="1433491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191991" y="3054928"/>
            <a:ext cx="1236627" cy="1433945"/>
          </a:xfrm>
          <a:prstGeom prst="rect">
            <a:avLst/>
          </a:prstGeom>
        </p:spPr>
      </p:pic>
      <p:pic>
        <p:nvPicPr>
          <p:cNvPr id="52" name="Picture 51"/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6600749" y="3054928"/>
            <a:ext cx="1246909" cy="14339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74446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04669" y="3507250"/>
            <a:ext cx="4177145" cy="721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 Effect on </a:t>
            </a:r>
            <a:r>
              <a:rPr lang="en-US" sz="818" b="1" i="1" dirty="0">
                <a:latin typeface="Arial" panose="020B0604020202020204" pitchFamily="34" charset="0"/>
                <a:cs typeface="Arial" panose="020B0604020202020204" pitchFamily="34" charset="0"/>
              </a:rPr>
              <a:t>FXN</a:t>
            </a:r>
            <a:r>
              <a:rPr lang="en-US" sz="818" b="1" dirty="0">
                <a:latin typeface="Arial" panose="020B0604020202020204" pitchFamily="34" charset="0"/>
                <a:cs typeface="Arial" panose="020B0604020202020204" pitchFamily="34" charset="0"/>
              </a:rPr>
              <a:t> mRNA and protein levels from ICV administration of ss-siRNA-1 tin neonatal mouse CNS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qPCR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data analyzed with additional reference genes </a:t>
            </a:r>
            <a:r>
              <a:rPr lang="en-US" sz="818" i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818" i="1" dirty="0">
                <a:latin typeface="Arial" panose="020B0604020202020204" pitchFamily="34" charset="0"/>
                <a:cs typeface="Arial" panose="020B0604020202020204" pitchFamily="34" charset="0"/>
              </a:rPr>
              <a:t>Hprt1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blot data, related to Fig. 5. (A) Brain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cortex.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Cerebellum. </a:t>
            </a:r>
            <a:r>
              <a:rPr lang="en-US" sz="818" dirty="0">
                <a:latin typeface="Arial" panose="020B0604020202020204" pitchFamily="34" charset="0"/>
                <a:cs typeface="Arial" panose="020B0604020202020204" pitchFamily="34" charset="0"/>
              </a:rPr>
              <a:t>(C) Spinal cord. AVG±SEM. T-test # - p&lt;0.05, * - p&lt;0.01.</a:t>
            </a:r>
            <a:endParaRPr lang="lt-LT" sz="81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3714404" y="149629"/>
          <a:ext cx="1427711" cy="11531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8" name="Prism 9" r:id="rId3" imgW="2963917" imgH="2393584" progId="Prism9.Document">
                  <p:embed/>
                </p:oleObj>
              </mc:Choice>
              <mc:Fallback>
                <p:oleObj name="Prism 9" r:id="rId3" imgW="2963917" imgH="2393584" progId="Prism9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14404" y="149629"/>
                        <a:ext cx="1427711" cy="11531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5079769" y="149629"/>
          <a:ext cx="1427711" cy="11531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9" name="Prism 9" r:id="rId5" imgW="2963917" imgH="2393584" progId="Prism9.Document">
                  <p:embed/>
                </p:oleObj>
              </mc:Choice>
              <mc:Fallback>
                <p:oleObj name="Prism 9" r:id="rId5" imgW="2963917" imgH="2393584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079769" y="149629"/>
                        <a:ext cx="1427711" cy="11531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6519949" y="149629"/>
          <a:ext cx="1427711" cy="11531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0" name="Prism 9" r:id="rId7" imgW="2963917" imgH="2393584" progId="Prism9.Document">
                  <p:embed/>
                </p:oleObj>
              </mc:Choice>
              <mc:Fallback>
                <p:oleObj name="Prism 9" r:id="rId7" imgW="2963917" imgH="2393584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519949" y="149629"/>
                        <a:ext cx="1427711" cy="11531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3714404" y="1311967"/>
          <a:ext cx="1427711" cy="11531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1" name="Prism 9" r:id="rId9" imgW="2963917" imgH="2393584" progId="Prism9.Document">
                  <p:embed/>
                </p:oleObj>
              </mc:Choice>
              <mc:Fallback>
                <p:oleObj name="Prism 9" r:id="rId9" imgW="2963917" imgH="2393584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14404" y="1311967"/>
                        <a:ext cx="1427711" cy="11531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5079769" y="1311967"/>
          <a:ext cx="1427711" cy="11531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2" name="Prism 9" r:id="rId11" imgW="2963917" imgH="2393584" progId="Prism9.Document">
                  <p:embed/>
                </p:oleObj>
              </mc:Choice>
              <mc:Fallback>
                <p:oleObj name="Prism 9" r:id="rId11" imgW="2963917" imgH="2393584" progId="Prism9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079769" y="1311967"/>
                        <a:ext cx="1427711" cy="11531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/>
          </p:nvPr>
        </p:nvGraphicFramePr>
        <p:xfrm>
          <a:off x="6519949" y="1311967"/>
          <a:ext cx="1427711" cy="11531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3" name="Prism 9" r:id="rId13" imgW="2963917" imgH="2393584" progId="Prism9.Document">
                  <p:embed/>
                </p:oleObj>
              </mc:Choice>
              <mc:Fallback>
                <p:oleObj name="Prism 9" r:id="rId13" imgW="2963917" imgH="2393584" progId="Prism9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519949" y="1311967"/>
                        <a:ext cx="1427711" cy="11531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3577244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04955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438900" y="118457"/>
            <a:ext cx="324196" cy="23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5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lt-LT" sz="95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758046" y="2556164"/>
            <a:ext cx="1246909" cy="374761"/>
          </a:xfrm>
          <a:prstGeom prst="rect">
            <a:avLst/>
          </a:prstGeom>
        </p:spPr>
      </p:pic>
      <p:pic>
        <p:nvPicPr>
          <p:cNvPr id="19" name="Picture 18"/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5123411" y="2556164"/>
            <a:ext cx="1246909" cy="374073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569826" y="2556164"/>
            <a:ext cx="1246909" cy="375724"/>
          </a:xfrm>
          <a:prstGeom prst="rect">
            <a:avLst/>
          </a:prstGeom>
        </p:spPr>
      </p:pic>
      <p:pic>
        <p:nvPicPr>
          <p:cNvPr id="22" name="Picture 21"/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3758046" y="3023754"/>
            <a:ext cx="1246909" cy="374073"/>
          </a:xfrm>
          <a:prstGeom prst="rect">
            <a:avLst/>
          </a:prstGeom>
        </p:spPr>
      </p:pic>
      <p:pic>
        <p:nvPicPr>
          <p:cNvPr id="23" name="Picture 22"/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5123411" y="3023754"/>
            <a:ext cx="1246909" cy="374073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6569826" y="3023755"/>
            <a:ext cx="1246909" cy="3729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40304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9</Words>
  <Application>Microsoft Office PowerPoint</Application>
  <PresentationFormat>Widescreen</PresentationFormat>
  <Paragraphs>25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ha Thangaraj, Integra-PDY, IN</dc:creator>
  <cp:lastModifiedBy>Usha Thangaraj, Integra-PDY, IN</cp:lastModifiedBy>
  <cp:revision>2</cp:revision>
  <dcterms:created xsi:type="dcterms:W3CDTF">2022-03-09T18:05:30Z</dcterms:created>
  <dcterms:modified xsi:type="dcterms:W3CDTF">2022-03-09T18:05:54Z</dcterms:modified>
</cp:coreProperties>
</file>